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90" autoAdjust="0"/>
    <p:restoredTop sz="94660"/>
  </p:normalViewPr>
  <p:slideViewPr>
    <p:cSldViewPr snapToGrid="0">
      <p:cViewPr varScale="1">
        <p:scale>
          <a:sx n="69" d="100"/>
          <a:sy n="69" d="100"/>
        </p:scale>
        <p:origin x="271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727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238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995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1352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4855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727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923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672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1821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00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7778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065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38"/>
          <p:cNvSpPr/>
          <p:nvPr/>
        </p:nvSpPr>
        <p:spPr>
          <a:xfrm>
            <a:off x="509262" y="1384688"/>
            <a:ext cx="13743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fr-FR" sz="11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mpty</a:t>
            </a:r>
            <a:r>
              <a:rPr lang="fr-FR" sz="11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pGBKT7</a:t>
            </a:r>
            <a:endParaRPr lang="fr-FR" sz="11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067790" y="1097201"/>
            <a:ext cx="6612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 smtClean="0">
                <a:latin typeface="Times New Roman" pitchFamily="18" charset="0"/>
                <a:cs typeface="Times New Roman" pitchFamily="18" charset="0"/>
              </a:rPr>
              <a:t>[-LW]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5262851" y="1097201"/>
            <a:ext cx="864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 smtClean="0">
                <a:latin typeface="Times New Roman" pitchFamily="18" charset="0"/>
                <a:cs typeface="Times New Roman" pitchFamily="18" charset="0"/>
              </a:rPr>
              <a:t>[-LWHA]</a:t>
            </a:r>
          </a:p>
        </p:txBody>
      </p:sp>
      <p:sp>
        <p:nvSpPr>
          <p:cNvPr id="48" name="Rectangle 47"/>
          <p:cNvSpPr/>
          <p:nvPr/>
        </p:nvSpPr>
        <p:spPr>
          <a:xfrm>
            <a:off x="3728794" y="705335"/>
            <a:ext cx="103610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fr-FR" sz="11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AD-Eph</a:t>
            </a:r>
            <a:endParaRPr lang="fr-FR" sz="11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37157" y="2176534"/>
            <a:ext cx="5931681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: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ion activation of the GAL4-responsive promoter by the Eph 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tial domain.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yeast strain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2HGold was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-transformed with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AD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Eph and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pty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BKT7. Three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nies were allowed to grow on a medium lacking leucine and tryptophan [-LW] before being transferred onto a selective medium deprived of leucine, tryptophan, histidine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-LWH] an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enine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-LWHA]. Yeast cells were grown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28°C for 3 days on [-LW] and for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 days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-LWH] and [-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WHA]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735591" y="1097201"/>
            <a:ext cx="6612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 smtClean="0">
                <a:latin typeface="Times New Roman" pitchFamily="18" charset="0"/>
                <a:cs typeface="Times New Roman" pitchFamily="18" charset="0"/>
              </a:rPr>
              <a:t>[-LWH]</a:t>
            </a:r>
          </a:p>
        </p:txBody>
      </p:sp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2623126" y="4650352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pic>
        <p:nvPicPr>
          <p:cNvPr id="1025" name="Picture 1" descr="SD-TLH003"/>
          <p:cNvPicPr>
            <a:picLocks noChangeAspect="1" noChangeArrowheads="1"/>
          </p:cNvPicPr>
          <p:nvPr/>
        </p:nvPicPr>
        <p:blipFill>
          <a:blip r:embed="rId2" cstate="print">
            <a:lum brigh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95" t="16519" r="1567" b="75674"/>
          <a:stretch>
            <a:fillRect/>
          </a:stretch>
        </p:blipFill>
        <p:spPr bwMode="auto">
          <a:xfrm>
            <a:off x="3217154" y="1388648"/>
            <a:ext cx="1616075" cy="352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4"/>
          <p:cNvSpPr>
            <a:spLocks noChangeArrowheads="1"/>
          </p:cNvSpPr>
          <p:nvPr/>
        </p:nvSpPr>
        <p:spPr bwMode="auto">
          <a:xfrm>
            <a:off x="299794" y="1736896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pic>
        <p:nvPicPr>
          <p:cNvPr id="1027" name="Picture 3" descr="SD-TL002"/>
          <p:cNvPicPr>
            <a:picLocks noChangeAspect="1" noChangeArrowheads="1"/>
          </p:cNvPicPr>
          <p:nvPr/>
        </p:nvPicPr>
        <p:blipFill>
          <a:blip r:embed="rId3" cstate="print">
            <a:lum brigh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21" t="16919" r="1184" b="75330"/>
          <a:stretch>
            <a:fillRect/>
          </a:stretch>
        </p:blipFill>
        <p:spPr bwMode="auto">
          <a:xfrm>
            <a:off x="1565281" y="1387060"/>
            <a:ext cx="1614488" cy="355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1441615" y="6190255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10" name="Rectangle 8"/>
          <p:cNvSpPr>
            <a:spLocks noChangeArrowheads="1"/>
          </p:cNvSpPr>
          <p:nvPr/>
        </p:nvSpPr>
        <p:spPr bwMode="auto">
          <a:xfrm>
            <a:off x="128954" y="4468017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pic>
        <p:nvPicPr>
          <p:cNvPr id="1031" name="Picture 7" descr="SD-AHTL004"/>
          <p:cNvPicPr>
            <a:picLocks noChangeAspect="1" noChangeArrowheads="1"/>
          </p:cNvPicPr>
          <p:nvPr/>
        </p:nvPicPr>
        <p:blipFill>
          <a:blip r:embed="rId4" cstate="print">
            <a:lum brigh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89" t="16960" r="1282" b="75221"/>
          <a:stretch>
            <a:fillRect/>
          </a:stretch>
        </p:blipFill>
        <p:spPr bwMode="auto">
          <a:xfrm>
            <a:off x="4870615" y="1387854"/>
            <a:ext cx="1616075" cy="354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322591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4</TotalTime>
  <Words>103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34</cp:revision>
  <cp:lastPrinted>2017-07-31T06:53:54Z</cp:lastPrinted>
  <dcterms:created xsi:type="dcterms:W3CDTF">2017-07-28T14:55:05Z</dcterms:created>
  <dcterms:modified xsi:type="dcterms:W3CDTF">2018-02-08T13:00:00Z</dcterms:modified>
</cp:coreProperties>
</file>